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6" r:id="rId2"/>
    <p:sldId id="297" r:id="rId3"/>
    <p:sldId id="298" r:id="rId4"/>
    <p:sldId id="299" r:id="rId5"/>
    <p:sldId id="300" r:id="rId6"/>
    <p:sldId id="301" r:id="rId7"/>
    <p:sldId id="291" r:id="rId8"/>
    <p:sldId id="302" r:id="rId9"/>
    <p:sldId id="303" r:id="rId10"/>
  </p:sldIdLst>
  <p:sldSz cx="9906000" cy="13208000"/>
  <p:notesSz cx="6797675" cy="9928225"/>
  <p:defaultTextStyle>
    <a:defPPr>
      <a:defRPr lang="ko-KR"/>
    </a:defPPr>
    <a:lvl1pPr marL="0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1pPr>
    <a:lvl2pPr marL="599023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2pPr>
    <a:lvl3pPr marL="1198047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3pPr>
    <a:lvl4pPr marL="1797070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4pPr>
    <a:lvl5pPr marL="2396094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5pPr>
    <a:lvl6pPr marL="2995117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6pPr>
    <a:lvl7pPr marL="3594141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7pPr>
    <a:lvl8pPr marL="4193164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8pPr>
    <a:lvl9pPr marL="4792188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2" userDrawn="1">
          <p15:clr>
            <a:srgbClr val="A4A3A4"/>
          </p15:clr>
        </p15:guide>
        <p15:guide id="2" pos="3143" userDrawn="1">
          <p15:clr>
            <a:srgbClr val="A4A3A4"/>
          </p15:clr>
        </p15:guide>
        <p15:guide id="3" pos="240" userDrawn="1">
          <p15:clr>
            <a:srgbClr val="A4A3A4"/>
          </p15:clr>
        </p15:guide>
        <p15:guide id="4" orient="horz" pos="168" userDrawn="1">
          <p15:clr>
            <a:srgbClr val="A4A3A4"/>
          </p15:clr>
        </p15:guide>
        <p15:guide id="5" pos="3347" userDrawn="1">
          <p15:clr>
            <a:srgbClr val="A4A3A4"/>
          </p15:clr>
        </p15:guide>
        <p15:guide id="6" pos="557" userDrawn="1">
          <p15:clr>
            <a:srgbClr val="A4A3A4"/>
          </p15:clr>
        </p15:guide>
        <p15:guide id="7" pos="5864" userDrawn="1">
          <p15:clr>
            <a:srgbClr val="A4A3A4"/>
          </p15:clr>
        </p15:guide>
        <p15:guide id="8" orient="horz" pos="4772" userDrawn="1">
          <p15:clr>
            <a:srgbClr val="A4A3A4"/>
          </p15:clr>
        </p15:guide>
        <p15:guide id="9" orient="horz" pos="849" userDrawn="1">
          <p15:clr>
            <a:srgbClr val="A4A3A4"/>
          </p15:clr>
        </p15:guide>
        <p15:guide id="10" orient="horz" pos="338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F3"/>
    <a:srgbClr val="FFFFE1"/>
    <a:srgbClr val="EBFEE8"/>
    <a:srgbClr val="DEFD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DF2FBC-25AD-48F5-9971-1A82F7995A42}" v="1" dt="2021-08-05T08:43:47.17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보통 스타일 3 - 강조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보통 스타일 3 - 강조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보통 스타일 3 - 강조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3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3126" y="96"/>
      </p:cViewPr>
      <p:guideLst>
        <p:guide orient="horz" pos="622"/>
        <p:guide pos="3143"/>
        <p:guide pos="240"/>
        <p:guide orient="horz" pos="168"/>
        <p:guide pos="3347"/>
        <p:guide pos="557"/>
        <p:guide pos="5864"/>
        <p:guide orient="horz" pos="4772"/>
        <p:guide orient="horz" pos="849"/>
        <p:guide orient="horz" pos="338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u Seung-Yup" userId="dc216b2ecdfe7d16" providerId="LiveId" clId="{EBDF2FBC-25AD-48F5-9971-1A82F7995A42}"/>
    <pc:docChg chg="addSld modSld">
      <pc:chgData name="Ku Seung-Yup" userId="dc216b2ecdfe7d16" providerId="LiveId" clId="{EBDF2FBC-25AD-48F5-9971-1A82F7995A42}" dt="2021-08-05T08:43:47.172" v="0"/>
      <pc:docMkLst>
        <pc:docMk/>
      </pc:docMkLst>
      <pc:sldChg chg="add">
        <pc:chgData name="Ku Seung-Yup" userId="dc216b2ecdfe7d16" providerId="LiveId" clId="{EBDF2FBC-25AD-48F5-9971-1A82F7995A42}" dt="2021-08-05T08:43:47.172" v="0"/>
        <pc:sldMkLst>
          <pc:docMk/>
          <pc:sldMk cId="2070974084" sldId="291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3584321795" sldId="296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2017422933" sldId="297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3208226127" sldId="298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2684454176" sldId="299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863590136" sldId="300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2988215420" sldId="301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2426436343" sldId="302"/>
        </pc:sldMkLst>
      </pc:sldChg>
      <pc:sldChg chg="add">
        <pc:chgData name="Ku Seung-Yup" userId="dc216b2ecdfe7d16" providerId="LiveId" clId="{EBDF2FBC-25AD-48F5-9971-1A82F7995A42}" dt="2021-08-05T08:43:47.172" v="0"/>
        <pc:sldMkLst>
          <pc:docMk/>
          <pc:sldMk cId="954429660" sldId="30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644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4058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637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713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06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4326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0073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728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8231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343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2018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3940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90570" rtl="0" eaLnBrk="1" latinLnBrk="1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1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1001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1. The number of total transcripts and after filtering. </a:t>
            </a:r>
            <a:endParaRPr lang="ko-KR" altLang="en-US" sz="1800" b="1" dirty="0"/>
          </a:p>
        </p:txBody>
      </p:sp>
      <p:graphicFrame>
        <p:nvGraphicFramePr>
          <p:cNvPr id="5" name="표 4"/>
          <p:cNvGraphicFramePr>
            <a:graphicFrameLocks noGrp="1"/>
          </p:cNvGraphicFramePr>
          <p:nvPr/>
        </p:nvGraphicFramePr>
        <p:xfrm>
          <a:off x="1004473" y="1370698"/>
          <a:ext cx="7920882" cy="33711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8685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3350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3350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3350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3350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18160">
                <a:tc rowSpan="2">
                  <a:txBody>
                    <a:bodyPr/>
                    <a:lstStyle/>
                    <a:p>
                      <a:pPr algn="just" latinLnBrk="1"/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FPKM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PM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81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1</a:t>
                      </a:r>
                    </a:p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2</a:t>
                      </a:r>
                    </a:p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1</a:t>
                      </a:r>
                    </a:p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2</a:t>
                      </a:r>
                    </a:p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TN1711R209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6845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Raw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24958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6845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case or control &gt; 5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0410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0329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1427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153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6845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Log2FC</a:t>
                      </a:r>
                      <a:r>
                        <a:rPr lang="en-US" altLang="ko-KR" sz="1600" b="1" baseline="0" dirty="0">
                          <a:latin typeface="+mn-lt"/>
                        </a:rPr>
                        <a:t> &gt;= 1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728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534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552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389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6845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Log2FC &lt;= -1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606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711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363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>
                          <a:latin typeface="+mn-lt"/>
                        </a:rPr>
                        <a:t>1547</a:t>
                      </a:r>
                      <a:endParaRPr lang="ko-KR" altLang="en-US" sz="1600" b="1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84321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004" y="166165"/>
            <a:ext cx="9311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2. Target genes for the reproductive span of the ovary selected using the public database.</a:t>
            </a:r>
            <a:endParaRPr lang="ko-KR" altLang="en-US" sz="1800" b="1" dirty="0"/>
          </a:p>
        </p:txBody>
      </p:sp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344488" y="1366410"/>
          <a:ext cx="9217025" cy="1625586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102275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942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25586">
                <a:tc>
                  <a:txBody>
                    <a:bodyPr/>
                    <a:lstStyle/>
                    <a:p>
                      <a:pPr marL="0" marR="0" indent="0" algn="ctr" defTabSz="99057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u="none" strike="noStrike" dirty="0">
                          <a:effectLst/>
                          <a:latin typeface="+mn-lt"/>
                        </a:rPr>
                        <a:t>Target genes</a:t>
                      </a:r>
                      <a:endParaRPr lang="en-US" altLang="ko-KR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just" defTabSz="99057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 kern="1200" dirty="0">
                          <a:effectLst/>
                        </a:rPr>
                        <a:t>Acur2, Acvr2a, Acvr2b, Alk1, Alk2,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 Alk3, Alk4, Alk5, Alk6, Alk7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Amh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Ar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Areg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Bdnf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Bmp15, Bmp2, Bmp4, Bmp7, Bmpr1b, Bmpr2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Btc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Ccnd2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Cga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Cyp19a1, E2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Egfr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Ereg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Erk1, Erk2, Esr1, Esr2, Fgf2, Fgf7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Figla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Foxl2, Foxo1, Foxo2, Foxo3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Fshb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Fshr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Gdf9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Ghr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Gja1, Gja4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Gnrh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Gsk3, Hesx1, Igf1, </a:t>
                      </a:r>
                    </a:p>
                    <a:p>
                      <a:pPr marL="0" marR="0" indent="0" algn="just" defTabSz="99057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 kern="1200" baseline="0" dirty="0" err="1">
                          <a:effectLst/>
                        </a:rPr>
                        <a:t>Inha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Inhba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Inhbb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Kit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Kitl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Lep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Lh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Lhb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Lhcgr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Lhx3, Lhx8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Lif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Ngf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Ngfb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Nobox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Nr5a1, Nt4, Nt5, </a:t>
                      </a:r>
                    </a:p>
                    <a:p>
                      <a:pPr marL="0" marR="0" indent="0" algn="just" defTabSz="99057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 kern="1200" baseline="0" dirty="0">
                          <a:effectLst/>
                        </a:rPr>
                        <a:t>Ntrk2, Otx1, Pi3k, Pit1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Pka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Pou5f1, Prop1, Ptx3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Ras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Rspo1, Sf1, Smad1, Smad2, Smad3, Smad4, </a:t>
                      </a:r>
                    </a:p>
                    <a:p>
                      <a:pPr marL="0" marR="0" indent="0" algn="just" defTabSz="99057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none" strike="noStrike" kern="1200" baseline="0" dirty="0">
                          <a:effectLst/>
                        </a:rPr>
                        <a:t>Smad5, Smad8, Sohlh1, Sohlh2, </a:t>
                      </a:r>
                      <a:r>
                        <a:rPr lang="en-US" sz="1600" u="none" strike="noStrike" kern="1200" baseline="0" dirty="0" err="1">
                          <a:effectLst/>
                        </a:rPr>
                        <a:t>Srctk</a:t>
                      </a:r>
                      <a:r>
                        <a:rPr lang="en-US" sz="1600" u="none" strike="noStrike" kern="1200" baseline="0" dirty="0">
                          <a:effectLst/>
                        </a:rPr>
                        <a:t>, Taf4b, Tnfaip6, Wnt4                                                               </a:t>
                      </a:r>
                      <a:endParaRPr lang="en-US" sz="1600" b="1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74229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004" y="166165"/>
            <a:ext cx="10056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3. mRNAs-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interaction confirmed by database in the reproductively-aged mouse ovary. </a:t>
            </a:r>
            <a:endParaRPr lang="ko-KR" altLang="en-US" sz="1800" b="1" dirty="0"/>
          </a:p>
        </p:txBody>
      </p:sp>
      <p:graphicFrame>
        <p:nvGraphicFramePr>
          <p:cNvPr id="6" name="표 5"/>
          <p:cNvGraphicFramePr>
            <a:graphicFrameLocks noGrp="1"/>
          </p:cNvGraphicFramePr>
          <p:nvPr/>
        </p:nvGraphicFramePr>
        <p:xfrm>
          <a:off x="915970" y="646154"/>
          <a:ext cx="8068692" cy="12530026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17322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322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5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888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7679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430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Ge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microRNA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 err="1">
                          <a:effectLst/>
                        </a:rPr>
                        <a:t>miRDB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 err="1">
                          <a:effectLst/>
                        </a:rPr>
                        <a:t>miRTarBas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 err="1">
                          <a:effectLst/>
                        </a:rPr>
                        <a:t>TarBas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 err="1">
                          <a:effectLst/>
                        </a:rPr>
                        <a:t>TargetSca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ABHD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ABHD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ACVR1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210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ARRDC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01a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ATP1B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BACH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55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BACH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70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APN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24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CD32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22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DC14B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OL3A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9b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OL4A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9b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OL9A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0e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RAMP1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49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CTDSP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24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TDSP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TDSP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26a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DCAF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36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EZH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26a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FAM117B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30e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FOXO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27a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GJA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a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HEBP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124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ITM2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9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ITPR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IWS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35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JAKMIP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0e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JPH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27a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KCNK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6a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KLHL1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466f-3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LIF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7a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LIN28B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AP4K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a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APK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36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GAT4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6a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KX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NME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GFOD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PCM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AIP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32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PALL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ATZ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6a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PDCD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1a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M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RKAA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35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SD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36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TPN1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TPN1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TPN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70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RAB11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RAB3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RAP1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mmu-miR-9-5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RHOQ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6a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CN2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DC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GK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55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LC40A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NTA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OAT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70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PAS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0e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STO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FDP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2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JP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MED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MEM109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NFAIP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3a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PD52L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RIM2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70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TULP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UTR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VAMP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VAMP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9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VAT1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30e-5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3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XRCC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4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XYLT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5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5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ZBTB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29a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6"/>
                  </a:ext>
                </a:extLst>
              </a:tr>
              <a:tr h="1605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ZCCHC2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mu-miR-124-3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4884" marR="4884" marT="4884" marB="0" anchor="ctr"/>
                </a:tc>
                <a:extLst>
                  <a:ext uri="{0D108BD9-81ED-4DB2-BD59-A6C34878D82A}">
                    <a16:rowId xmlns:a16="http://schemas.microsoft.com/office/drawing/2014/main" val="100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8226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2267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4. Expressions of genes and interactive 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between 2W and 20W.</a:t>
            </a:r>
            <a:endParaRPr lang="ko-KR" altLang="ko-KR" sz="1800" dirty="0"/>
          </a:p>
        </p:txBody>
      </p:sp>
      <p:sp>
        <p:nvSpPr>
          <p:cNvPr id="3" name="TextBox 2"/>
          <p:cNvSpPr txBox="1"/>
          <p:nvPr/>
        </p:nvSpPr>
        <p:spPr>
          <a:xfrm>
            <a:off x="637960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1213608" y="1383634"/>
          <a:ext cx="7474688" cy="8229596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6867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282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Increased genes (n=27)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ecreased genes (n=26)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2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ACVR1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210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P1S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ADA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a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PCDD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ARRDC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301a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TP1B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ATR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36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BACH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CLCN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a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OL3A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CRAMP1L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499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OL4A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DCAF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36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TDS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EDEM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741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EZH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ENO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665-3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ITM2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F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381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LIN28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GJA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a-3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GAT4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HIF1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8a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OPCM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IRF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8a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AI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32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IWS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335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ATZ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KIF3B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36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DCD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1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AP4K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a-3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TPN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APK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36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RAP1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PIK3R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381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RHOQ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PRKAA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335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CN2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PSD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36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GK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55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SLC35E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665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OCS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SMAD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mmu-miR-18a-5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PAR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SNX2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30b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TMEM1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SPP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81d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TRIM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STK4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31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VAMP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>
                          <a:effectLst/>
                          <a:latin typeface="+mn-lt"/>
                        </a:rPr>
                        <a:t>XYLT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25-3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ZBTB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9a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ZBTB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effectLst/>
                          <a:latin typeface="+mn-lt"/>
                        </a:rPr>
                        <a:t>mmu-miR-106b-5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844541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2267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4. Expressions of target genes and interactive 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between 2W and 20W.</a:t>
            </a:r>
            <a:endParaRPr lang="ko-KR" altLang="ko-KR" sz="1800" dirty="0"/>
          </a:p>
        </p:txBody>
      </p:sp>
      <p:sp>
        <p:nvSpPr>
          <p:cNvPr id="4" name="TextBox 3"/>
          <p:cNvSpPr txBox="1"/>
          <p:nvPr/>
        </p:nvSpPr>
        <p:spPr>
          <a:xfrm>
            <a:off x="637960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graphicFrame>
        <p:nvGraphicFramePr>
          <p:cNvPr id="5" name="표 4"/>
          <p:cNvGraphicFramePr>
            <a:graphicFrameLocks noGrp="1"/>
          </p:cNvGraphicFramePr>
          <p:nvPr/>
        </p:nvGraphicFramePr>
        <p:xfrm>
          <a:off x="1213608" y="1383634"/>
          <a:ext cx="7474688" cy="935610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6867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282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0W &gt; 2W, Up to</a:t>
                      </a:r>
                      <a:r>
                        <a:rPr lang="en-US" sz="14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own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2W &gt; 20W, Up to down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2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BCA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44-3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RHGAP1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62-3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3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EPHA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7a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GPAT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4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62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PBA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IL6S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42a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VL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5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YLI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06a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4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CNJ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IP2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M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ST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ERLIN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22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FBXO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C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0e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ITFG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KCNK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KIF5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BNL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0e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KNK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7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TDH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0e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LOD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4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PAR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2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PP1C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ERINC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GPP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IRT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2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LC35A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0e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TT3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TIMP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8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UTR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06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40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3590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2267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4. Expressions of target genes and interactive 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between 2W and 20W.</a:t>
            </a:r>
            <a:endParaRPr lang="ko-KR" altLang="ko-KR" sz="1800" dirty="0"/>
          </a:p>
        </p:txBody>
      </p:sp>
      <p:sp>
        <p:nvSpPr>
          <p:cNvPr id="3" name="TextBox 2"/>
          <p:cNvSpPr txBox="1"/>
          <p:nvPr/>
        </p:nvSpPr>
        <p:spPr>
          <a:xfrm>
            <a:off x="637960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1245692" y="1383634"/>
          <a:ext cx="7474688" cy="1752152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6867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686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1282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W &gt; 2W, down to up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+mn-ea"/>
                        </a:rPr>
                        <a:t>2W &gt; 20W, down to up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2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miRNA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OPS7B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329-3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JUB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25b-5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FAM83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9a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CND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let-7b-5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RBFOX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204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DSE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9b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TTC39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9a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K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mu-miR-128-3p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882154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5. Correlation of 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with up- and down-regulated genes as reproductively-aged and confirmation using database.</a:t>
            </a:r>
            <a:endParaRPr lang="ko-KR" altLang="ko-KR" sz="1800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344488" y="1801082"/>
          <a:ext cx="9217025" cy="8040201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1379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201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678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35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999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443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7498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6783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5146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12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Gen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miRN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W_Gene</a:t>
                      </a:r>
                    </a:p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(rank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6W_Gene</a:t>
                      </a:r>
                    </a:p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(rank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0W_Gene</a:t>
                      </a:r>
                    </a:p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(rank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miRDB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miRTarBa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TarBa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</a:rPr>
                        <a:t>TargetSca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ACVR1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210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4.57(8980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5.01(9122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5.5(9333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ADA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a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.62(10203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0.1(1175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0.74(11900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ARRDC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301a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8.26(15820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39.23(16673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4.69(17688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ATR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36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7.37(10619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0.18(11791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2.37(12492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CLCN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a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.54(11667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4.96(13388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6.52(13678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CRAMP1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mu-miR-499-5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4.85(9152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.34(9889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8.7(11009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DCAF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36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1.33(12338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1.68(12380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2(12366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EDEM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741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7.44(1065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2.21(12555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4.13(13068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ENO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mu-miR-665-3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72(5340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99(5770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.36(6306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F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381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6.48(13901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9.94(14529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4.19(17674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GJA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mu-miR-1a-3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59.89(1847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44.37(18886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770.48(18917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HIF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8a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33.48(16336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44.58(16977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0.36(17584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IRF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8a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0.12(11898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1.67(12376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3.79(12961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IWS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mu-miR-335-5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5.11(9324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5.84(9569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7.51(10431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KIF3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36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7.14(10495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9.81(11631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1.35(12129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AP4K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a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6.16(13818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7.44(13979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7.62(1394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AP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mmu-miR-136-5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47.19(17151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55.65(17381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63.74(1766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PIK3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381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25.06(15458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6.8(15614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32.96(16263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PRKA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335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.03(589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.98(6914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.15(7123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PSD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36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4.56(8972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5.11(9171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7.36(10346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SLC35E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665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7.56(10720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7.94(10744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.26(11287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SMA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8a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9.27(11538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.52(11513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.92(1158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SNX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30b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9.25(11527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0.61(11969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2.73(12612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SPP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81d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0.5(4775.5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4.88(15348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00.63(18204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STK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31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2.41(12718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2.51(12686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6.51(13674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XYL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25-3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10.97(12217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1.84(12436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2.65(12589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ZBTB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mmu-miR-106b-5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8.66(11239)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8.94(11224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.15(11228.5)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2303" y="1157049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0709740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9755" y="1170697"/>
            <a:ext cx="318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</a:t>
            </a:r>
            <a:endParaRPr lang="ko-KR" altLang="en-US" sz="1200" b="1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714057" y="1605242"/>
          <a:ext cx="8821775" cy="763514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81395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595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71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1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071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320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053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270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270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12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</a:rPr>
                        <a:t>miRN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W_Gene(rank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6W_Gene(rank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0W_Gene(rank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</a:rPr>
                        <a:t>miRD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</a:rPr>
                        <a:t>miRTarBa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</a:rPr>
                        <a:t>TarBa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</a:rPr>
                        <a:t>TargetSca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P1S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.38(13033)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89(11661)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57(11418)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PCDD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12(11898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7(9491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59(938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TP1B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5.6(1797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0.56(1721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3.82(1633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ACH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28(6255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72(5297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65(5212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OL3A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73.41(1883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9.95(1862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91.04(1861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OL4A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5.84(15553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.58(14655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.93(14035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TDS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8.17(17998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4.61(1781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4.18(1767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EZH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3.53(15244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.24(1393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.04(1381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ITM2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21.2(1864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90.32(1857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7.73(1848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LIN28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12(277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9(2500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3(141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GAT4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.3(7288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49(6404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.11(6010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OPCM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7(210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5(1952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01(92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AI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132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0.4(1860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78.17(1854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69.19(1856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ATZ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.84(1286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.56(1270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.51(12187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DCD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1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8.87(1770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8.35(1746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3.16(1693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TPN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9.01(1671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5.15(1641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2.44(1621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AP1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6.15(1819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3.4(18174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0.14(18199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RHOQ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6a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2.3(12678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.84(1243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FF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.74(12268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CN2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99(583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81(547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0.58(505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GK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155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97(9841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4(9343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.13(7898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OCS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0.37(1199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9.11(1131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.86(11090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PAR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9b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129.05(1893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768.36(1890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93.82(1888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MEM1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1.62(17297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5.55(1701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6.28(16526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TRIM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5.98(13771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5.18(1344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4.33(1311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VAMP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9-5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5.11(17396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4.61(1697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41.94(16882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1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ZBTB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mmu-miR-29a-3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6.21(998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84(9569.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.63(940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effectLst/>
                        </a:rPr>
                        <a:t>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</a:rPr>
                        <a:t>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5. Correlation of </a:t>
            </a:r>
            <a:r>
              <a:rPr lang="en-US" altLang="ko-KR" sz="1800" b="1" dirty="0" err="1"/>
              <a:t>miRNAs</a:t>
            </a:r>
            <a:r>
              <a:rPr lang="en-US" altLang="ko-KR" sz="1800" b="1" dirty="0"/>
              <a:t> with up- and down-regulated genes as reproductively-aged and confirmation using database.</a:t>
            </a:r>
            <a:endParaRPr lang="ko-KR" altLang="ko-KR" sz="1800" dirty="0"/>
          </a:p>
        </p:txBody>
      </p:sp>
    </p:spTree>
    <p:extLst>
      <p:ext uri="{BB962C8B-B14F-4D97-AF65-F5344CB8AC3E}">
        <p14:creationId xmlns:p14="http://schemas.microsoft.com/office/powerpoint/2010/main" val="24264363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1695045" y="1901060"/>
          <a:ext cx="6530685" cy="101346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9329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3295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533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Gen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6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0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2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6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20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PIWIL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1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1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0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652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302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87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PIWIL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4.6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5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5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904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492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494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PIWIL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0.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>
                          <a:effectLst/>
                        </a:rPr>
                        <a:t>0.1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0.0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253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336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u="none" strike="noStrike" dirty="0">
                          <a:effectLst/>
                        </a:rPr>
                        <a:t>187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739777" y="5175687"/>
          <a:ext cx="8616873" cy="607063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9119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663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63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6632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055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055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0555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9642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9642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96421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Gen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6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20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2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6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rank_20W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with_piwil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with_piwil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with_piwil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FOXL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6.6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3.6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4.8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743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628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741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70775162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55823814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89520488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FOXO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0.5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7.9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0.8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205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0751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1958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82111067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40338853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95970047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NANO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3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1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12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00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274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89340514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61165655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70490439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POU5F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4.2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.1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.6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535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9208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8246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5465864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9787069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0650395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LIN28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2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3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18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4095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62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7468932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9630071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0442991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SOX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0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48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293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142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18898223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99999779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13206763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SOX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0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10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0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142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0907841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6018452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40180718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KLF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21.5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0.6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5.8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8305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6749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6493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3738515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9887454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08281208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PRDM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4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6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.0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4744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11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94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84358427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68826741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62983682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NANOS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5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7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5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4869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38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079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56702046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70020684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79890010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UTF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1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2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1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241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57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2953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8198050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00209945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9124070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CD3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3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.7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.1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32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8305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856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32321033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99064451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00653969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DAZ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.7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.5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.6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9700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748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6568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40537166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7475832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9466320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DDX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7.8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3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.4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0845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628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641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17832486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9991626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1428065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SYCP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9.0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1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9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5904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98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79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19445011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9999397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12654318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RNF1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6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7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6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623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27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212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434683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985576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07656501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TDRD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6.9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1.5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23.1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401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609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5089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41077627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81646732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67862248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TDRD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.8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3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777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4181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11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1988799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9996808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12206018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SOX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.9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.09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.4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95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7022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813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91641462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56793362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74226764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GATA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7.4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60.3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8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7677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7524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798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99981502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172129117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95434239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98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76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87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945596307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19966749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TEAD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7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.28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5425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5664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6210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80295506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-0.73846075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57258581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TFAP2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38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2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2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383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640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869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0128289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83951691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304821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LHX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22.5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2.54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4.46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5091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2700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8764.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6073924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89580865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0.32422637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334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WT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00.3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35.2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37.35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813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16419.5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16604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160365753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>
                          <a:effectLst/>
                        </a:rPr>
                        <a:t>0.999514446</a:t>
                      </a:r>
                      <a:endParaRPr lang="en-US" altLang="ko-KR" sz="12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u="none" strike="noStrike" dirty="0">
                          <a:effectLst/>
                        </a:rPr>
                        <a:t>-0.160817631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Table S6. Correlation of </a:t>
            </a:r>
            <a:r>
              <a:rPr lang="en-US" altLang="ko-KR" sz="1800" b="1" dirty="0" err="1"/>
              <a:t>Piwil</a:t>
            </a:r>
            <a:r>
              <a:rPr lang="en-US" altLang="ko-KR" sz="1800" b="1" dirty="0"/>
              <a:t> gene family expression with frequently expressed  target genes in the reproductively-aged mouse ovary. </a:t>
            </a:r>
            <a:endParaRPr lang="ko-KR" altLang="ko-KR" sz="1800" dirty="0"/>
          </a:p>
        </p:txBody>
      </p:sp>
      <p:sp>
        <p:nvSpPr>
          <p:cNvPr id="5" name="TextBox 4"/>
          <p:cNvSpPr txBox="1"/>
          <p:nvPr/>
        </p:nvSpPr>
        <p:spPr>
          <a:xfrm>
            <a:off x="393051" y="1126507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09879" y="4500650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54429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45</TotalTime>
  <Words>2104</Words>
  <Application>Microsoft Office PowerPoint</Application>
  <PresentationFormat>Custom</PresentationFormat>
  <Paragraphs>150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ony</dc:creator>
  <cp:lastModifiedBy>MDPI</cp:lastModifiedBy>
  <cp:revision>160</cp:revision>
  <cp:lastPrinted>2021-04-24T07:19:29Z</cp:lastPrinted>
  <dcterms:created xsi:type="dcterms:W3CDTF">2021-03-28T04:56:26Z</dcterms:created>
  <dcterms:modified xsi:type="dcterms:W3CDTF">2021-10-09T10:08:15Z</dcterms:modified>
</cp:coreProperties>
</file>